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4" r:id="rId3"/>
    <p:sldId id="271" r:id="rId4"/>
    <p:sldId id="270" r:id="rId5"/>
    <p:sldId id="275" r:id="rId6"/>
    <p:sldId id="276" r:id="rId7"/>
    <p:sldId id="278" r:id="rId8"/>
    <p:sldId id="277" r:id="rId9"/>
    <p:sldId id="280" r:id="rId10"/>
    <p:sldId id="279" r:id="rId11"/>
    <p:sldId id="282" r:id="rId12"/>
    <p:sldId id="281" r:id="rId13"/>
    <p:sldId id="285" r:id="rId14"/>
    <p:sldId id="286" r:id="rId15"/>
    <p:sldId id="284" r:id="rId16"/>
    <p:sldId id="283" r:id="rId1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EBDF1B-5218-41B2-A01D-E6EFC14F4E6F}" type="datetimeFigureOut">
              <a:rPr lang="en-US" smtClean="0"/>
              <a:t>3/24/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0607E-8F38-40E3-AC61-895FD3A7AD85}" type="slidenum">
              <a:rPr lang="en-IN" smtClean="0"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ree living 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harmada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Phylum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30722" name="Picture 2" descr="C:\Users\welcome\Downloads\Particle associated phylum level Chaliyum png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4310" y="0"/>
            <a:ext cx="875538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article associated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harmada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Phylum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31746" name="Picture 2" descr="C:\Users\welcome\Downloads\Particle associated phylum level Darmadam (1)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4310" y="0"/>
            <a:ext cx="875538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article associated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Chaliy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Species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337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3999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article associated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harmada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Species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32770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27650" name="Picture 2" descr="C:\Users\welcome\Downloads\freeliving phylum level Darmadam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4310" y="0"/>
            <a:ext cx="875538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ree living 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Chaliy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Phylum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26626" name="Picture 2" descr="C:\Users\welcome\Downloads\freeliving phylum level chaliyum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4310" y="0"/>
            <a:ext cx="875538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ree living 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Chaliy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Species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28674" name="Picture 2" descr="C:\Users\welcome\Downloads\freeliving species level chaliyum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4310" y="0"/>
            <a:ext cx="875538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Free living 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Dharmada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Species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IN"/>
          </a:p>
        </p:txBody>
      </p:sp>
      <p:pic>
        <p:nvPicPr>
          <p:cNvPr id="29698" name="Picture 2" descr="C:\Users\welcome\Downloads\freeliving species level Darmadam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4310" y="0"/>
            <a:ext cx="8755380" cy="68580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1472" y="2357430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Particle associated–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Chaliyum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-Phylum level</a:t>
            </a:r>
            <a:endParaRPr lang="en-IN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1</TotalTime>
  <Words>40</Words>
  <Application>Microsoft Office PowerPoint</Application>
  <PresentationFormat>On-screen Show (4:3)</PresentationFormat>
  <Paragraphs>8</Paragraphs>
  <Slides>1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Office Theme</vt:lpstr>
      <vt:lpstr>Free living – Dharmadam-Phylum level</vt:lpstr>
      <vt:lpstr>PowerPoint Presentation</vt:lpstr>
      <vt:lpstr>Free living – Chaliyum-Phylum level</vt:lpstr>
      <vt:lpstr>PowerPoint Presentation</vt:lpstr>
      <vt:lpstr>Free living – Chaliyum-Species level</vt:lpstr>
      <vt:lpstr>PowerPoint Presentation</vt:lpstr>
      <vt:lpstr>Free living – Dharmadam-Species level</vt:lpstr>
      <vt:lpstr>PowerPoint Presentation</vt:lpstr>
      <vt:lpstr>Particle associated– Chaliyum-Phylum level</vt:lpstr>
      <vt:lpstr>PowerPoint Presentation</vt:lpstr>
      <vt:lpstr>Particle associated– Dharmadam-Phylum level</vt:lpstr>
      <vt:lpstr>PowerPoint Presentation</vt:lpstr>
      <vt:lpstr>Particle associated– Chaliyum-Species level</vt:lpstr>
      <vt:lpstr>PowerPoint Presentation</vt:lpstr>
      <vt:lpstr>Particle associated– Dharmadam-Species level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armadam – water quality parameters</dc:title>
  <dc:creator>welcome</dc:creator>
  <cp:lastModifiedBy>Arunaksharan</cp:lastModifiedBy>
  <cp:revision>4</cp:revision>
  <dcterms:created xsi:type="dcterms:W3CDTF">2021-03-19T14:43:19Z</dcterms:created>
  <dcterms:modified xsi:type="dcterms:W3CDTF">2021-03-24T10:35:21Z</dcterms:modified>
</cp:coreProperties>
</file>